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400675" cy="45005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1D188-5013-4D48-A7ED-4366684C30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0000" y="26010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8507D-D4D9-4086-8A60-0D34D05E83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76048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130D9-6150-42ED-B2B2-18E139D4F59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1340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557160" y="10494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000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1340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557160" y="2601000"/>
            <a:ext cx="15649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5B8410-846D-4B4B-841A-B3E2C161E5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99"/>
              </a:spcBef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E39FFA-46C8-4E9C-B1C1-09C8B5E9F6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96878-C31C-4754-B824-673FFDB16B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A0366-4EE0-4ACE-BB36-1E054D8B50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F2CB56-1B22-4C28-9B1A-E7E7F46D25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0000" y="180720"/>
            <a:ext cx="4860720" cy="3474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99"/>
              </a:spcBef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7ED9C-7B86-4C98-BE6A-DCCEC5EF30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C3FA2B-912F-4AEE-AF14-0764AE0B8D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760480" y="26010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5FEC1-8876-4025-BBDA-F54A062510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000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760480" y="1049400"/>
            <a:ext cx="237168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0000" y="2601000"/>
            <a:ext cx="4860720" cy="14166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indent="0">
              <a:spcBef>
                <a:spcPts val="499"/>
              </a:spcBef>
              <a:buNone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A9D5C-DBA0-4405-80AF-E50D3FAAF9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0000" y="180720"/>
            <a:ext cx="4860720" cy="7491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 algn="ct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0000" y="1049400"/>
            <a:ext cx="4860720" cy="297000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t">
            <a:normAutofit/>
          </a:bodyPr>
          <a:p>
            <a:pPr marL="210960" indent="-21096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458640" indent="-17604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706320" indent="-141120"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3" marL="988920" indent="-141120"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4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1271520" indent="-141120">
              <a:spcBef>
                <a:spcPts val="499"/>
              </a:spcBef>
              <a:buClr>
                <a:srgbClr val="000000"/>
              </a:buClr>
              <a:buFont typeface="Arial"/>
              <a:buChar char="»"/>
              <a:tabLst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69640" y="4172040"/>
            <a:ext cx="126036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lstStyle>
            <a:lvl1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844640" y="4172040"/>
            <a:ext cx="171144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p>
            <a:pPr indent="0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870000" y="4172040"/>
            <a:ext cx="1260360" cy="239760"/>
          </a:xfrm>
          <a:prstGeom prst="rect">
            <a:avLst/>
          </a:prstGeom>
          <a:noFill/>
          <a:ln w="0">
            <a:noFill/>
          </a:ln>
        </p:spPr>
        <p:txBody>
          <a:bodyPr lIns="56520" rIns="56520" tIns="28440" bIns="28440" anchor="ctr">
            <a:noAutofit/>
          </a:bodyPr>
          <a:lstStyle>
            <a:lvl1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fld id="{4F521EE0-ABA5-41A4-B78E-87DB94D632CC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-25560" y="17640"/>
            <a:ext cx="5078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ditional table 3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tatistical analysis of organelle densities within chloronemat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-46080" y="8701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plas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5"/>
          <p:cNvSpPr/>
          <p:nvPr/>
        </p:nvSpPr>
        <p:spPr>
          <a:xfrm>
            <a:off x="1027080" y="407880"/>
            <a:ext cx="134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 vs. Nucleus are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6"/>
          <p:cNvSpPr/>
          <p:nvPr/>
        </p:nvSpPr>
        <p:spPr>
          <a:xfrm>
            <a:off x="2614680" y="406440"/>
            <a:ext cx="961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3836880" y="406440"/>
            <a:ext cx="14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ucleus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-38160" y="117468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isom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9"/>
          <p:cNvSpPr/>
          <p:nvPr/>
        </p:nvSpPr>
        <p:spPr>
          <a:xfrm>
            <a:off x="-30240" y="147960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-28440" y="178452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1"/>
          <p:cNvSpPr/>
          <p:nvPr/>
        </p:nvSpPr>
        <p:spPr>
          <a:xfrm>
            <a:off x="-28440" y="40788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pical cel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"/>
          <p:cNvSpPr/>
          <p:nvPr/>
        </p:nvSpPr>
        <p:spPr>
          <a:xfrm>
            <a:off x="-49320" y="274464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hloroplast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13"/>
          <p:cNvSpPr/>
          <p:nvPr/>
        </p:nvSpPr>
        <p:spPr>
          <a:xfrm>
            <a:off x="1023840" y="2286000"/>
            <a:ext cx="1343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-oriented area vs. Nucleus are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4"/>
          <p:cNvSpPr/>
          <p:nvPr/>
        </p:nvSpPr>
        <p:spPr>
          <a:xfrm>
            <a:off x="2489040" y="2284560"/>
            <a:ext cx="12193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ip-oriented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5"/>
          <p:cNvSpPr/>
          <p:nvPr/>
        </p:nvSpPr>
        <p:spPr>
          <a:xfrm>
            <a:off x="3833640" y="2284560"/>
            <a:ext cx="149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ucleus area vs. Bas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6"/>
          <p:cNvSpPr/>
          <p:nvPr/>
        </p:nvSpPr>
        <p:spPr>
          <a:xfrm>
            <a:off x="-41400" y="3049560"/>
            <a:ext cx="127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isome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-33480" y="3354480"/>
            <a:ext cx="127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Golgi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8"/>
          <p:cNvSpPr/>
          <p:nvPr/>
        </p:nvSpPr>
        <p:spPr>
          <a:xfrm>
            <a:off x="-31680" y="365904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Mitochondri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9"/>
          <p:cNvSpPr/>
          <p:nvPr/>
        </p:nvSpPr>
        <p:spPr>
          <a:xfrm>
            <a:off x="-31680" y="2286000"/>
            <a:ext cx="12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b-apical cel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0"/>
          <p:cNvSpPr/>
          <p:nvPr/>
        </p:nvSpPr>
        <p:spPr>
          <a:xfrm>
            <a:off x="-19080" y="4068720"/>
            <a:ext cx="5348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djusted P values are shown for rejecting equivalence of means by ANOVA; values in bold indicate that the difference is statistically significant at the 0.05 level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1"/>
          <p:cNvSpPr/>
          <p:nvPr/>
        </p:nvSpPr>
        <p:spPr>
          <a:xfrm>
            <a:off x="1066680" y="27525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22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2"/>
          <p:cNvSpPr/>
          <p:nvPr/>
        </p:nvSpPr>
        <p:spPr>
          <a:xfrm>
            <a:off x="2465280" y="27525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034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3"/>
          <p:cNvSpPr/>
          <p:nvPr/>
        </p:nvSpPr>
        <p:spPr>
          <a:xfrm>
            <a:off x="3956040" y="27511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616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1063800" y="30574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36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462040" y="30574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4202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3952800" y="305604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9121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1065240" y="11811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8968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2463840" y="11811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761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3954600" y="11793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0994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1065240" y="8683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109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2463840" y="8683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8750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3954600" y="8668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323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1063800" y="14763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496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2462040" y="14763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19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5"/>
          <p:cNvSpPr/>
          <p:nvPr/>
        </p:nvSpPr>
        <p:spPr>
          <a:xfrm>
            <a:off x="3952800" y="14749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806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1065240" y="33526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955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7"/>
          <p:cNvSpPr/>
          <p:nvPr/>
        </p:nvSpPr>
        <p:spPr>
          <a:xfrm>
            <a:off x="2463840" y="335268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1333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8"/>
          <p:cNvSpPr/>
          <p:nvPr/>
        </p:nvSpPr>
        <p:spPr>
          <a:xfrm>
            <a:off x="3954600" y="335124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3752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9"/>
          <p:cNvSpPr/>
          <p:nvPr/>
        </p:nvSpPr>
        <p:spPr>
          <a:xfrm>
            <a:off x="1063800" y="178272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246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0"/>
          <p:cNvSpPr/>
          <p:nvPr/>
        </p:nvSpPr>
        <p:spPr>
          <a:xfrm>
            <a:off x="2462040" y="17827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2254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1"/>
          <p:cNvSpPr/>
          <p:nvPr/>
        </p:nvSpPr>
        <p:spPr>
          <a:xfrm>
            <a:off x="3952800" y="178128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6522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2"/>
          <p:cNvSpPr/>
          <p:nvPr/>
        </p:nvSpPr>
        <p:spPr>
          <a:xfrm>
            <a:off x="1063800" y="3666960"/>
            <a:ext cx="1272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9715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3"/>
          <p:cNvSpPr/>
          <p:nvPr/>
        </p:nvSpPr>
        <p:spPr>
          <a:xfrm>
            <a:off x="2462040" y="366696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5824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4"/>
          <p:cNvSpPr/>
          <p:nvPr/>
        </p:nvSpPr>
        <p:spPr>
          <a:xfrm>
            <a:off x="3952800" y="3665520"/>
            <a:ext cx="1273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65200"/>
                <a:tab algn="l" pos="1130400"/>
                <a:tab algn="l" pos="1695600"/>
                <a:tab algn="l" pos="2260440"/>
                <a:tab algn="l" pos="2825640"/>
                <a:tab algn="l" pos="3390840"/>
                <a:tab algn="l" pos="3956040"/>
                <a:tab algn="l" pos="4521240"/>
                <a:tab algn="l" pos="5086440"/>
                <a:tab algn="l" pos="5651640"/>
                <a:tab algn="l" pos="6216480"/>
                <a:tab algn="l" pos="6781680"/>
                <a:tab algn="l" pos="7346880"/>
                <a:tab algn="l" pos="7912080"/>
                <a:tab algn="l" pos="8477280"/>
                <a:tab algn="l" pos="9042480"/>
                <a:tab algn="l" pos="9607680"/>
                <a:tab algn="l" pos="10172880"/>
                <a:tab algn="l" pos="107377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.4615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traight Connector 45"/>
          <p:cNvSpPr/>
          <p:nvPr/>
        </p:nvSpPr>
        <p:spPr>
          <a:xfrm>
            <a:off x="23760" y="322200"/>
            <a:ext cx="5329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46"/>
          <p:cNvSpPr/>
          <p:nvPr/>
        </p:nvSpPr>
        <p:spPr>
          <a:xfrm>
            <a:off x="31680" y="3979800"/>
            <a:ext cx="532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Straight Connector 47"/>
          <p:cNvSpPr/>
          <p:nvPr/>
        </p:nvSpPr>
        <p:spPr>
          <a:xfrm>
            <a:off x="1030320" y="2151000"/>
            <a:ext cx="4321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9T00:48:23Z</dcterms:created>
  <dc:creator>fabiennefurt</dc:creator>
  <dc:description/>
  <dc:language>en-US</dc:language>
  <cp:lastModifiedBy>Furt, Fabienne</cp:lastModifiedBy>
  <dcterms:modified xsi:type="dcterms:W3CDTF">2012-02-29T03:18:25Z</dcterms:modified>
  <cp:revision>1</cp:revision>
  <dc:subject/>
  <dc:title>PowerPoint Presentation</dc:title>
</cp:coreProperties>
</file>